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4674"/>
  </p:normalViewPr>
  <p:slideViewPr>
    <p:cSldViewPr snapToGrid="0" snapToObjects="1">
      <p:cViewPr varScale="1">
        <p:scale>
          <a:sx n="131" d="100"/>
          <a:sy n="131" d="100"/>
        </p:scale>
        <p:origin x="376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E862B32-C26E-DB40-9D42-DEA32E7C3DB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6E9D2797-E743-4D4A-B3E6-0D8027F2A14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5706CE7-479D-1946-8482-F3F6390F46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3F11D4-5BE0-7942-80BE-75A29E70E498}" type="datetimeFigureOut">
              <a:rPr kumimoji="1" lang="ja-JP" altLang="en-US" smtClean="0"/>
              <a:t>2020/5/1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4A7226E-B127-BC49-8BFB-F2D5C733A2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22748B6-FA5C-7846-B21A-BE4A5D3E4A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E6FED-AF57-1140-9F16-FE5E9289E6A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430994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DB0BB52-E2AB-F044-B6ED-F8C6E834B3F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99CB82ED-7C48-304F-8AF3-A17D6762DD9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A66EC53-7EC2-9246-972F-6217D4AEE2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3F11D4-5BE0-7942-80BE-75A29E70E498}" type="datetimeFigureOut">
              <a:rPr kumimoji="1" lang="ja-JP" altLang="en-US" smtClean="0"/>
              <a:t>2020/5/1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5F7BB0A-B594-8149-8060-367FBD18DB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40DE2E5-3501-FE4A-8241-75C7733A4C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E6FED-AF57-1140-9F16-FE5E9289E6A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16150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6B5A7510-0D9E-7E42-9E3D-1EF45F0BAA9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22329710-594B-DA47-9068-E89A69BC1C5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05DF859-C86A-4D4F-A894-FBE0CB73A9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3F11D4-5BE0-7942-80BE-75A29E70E498}" type="datetimeFigureOut">
              <a:rPr kumimoji="1" lang="ja-JP" altLang="en-US" smtClean="0"/>
              <a:t>2020/5/1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718BAB6-BF32-CC4D-8A44-D1603922FB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F44825F-DEB3-8A48-A385-8E24571C71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E6FED-AF57-1140-9F16-FE5E9289E6A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886766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EEBE6DC-6AA7-F94F-A120-D7C9FC6F3A1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07A1B212-3324-004F-B3A5-6F408D6BF7F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2E44FE7-283E-F94B-9CCB-8B2BD2217A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3F11D4-5BE0-7942-80BE-75A29E70E498}" type="datetimeFigureOut">
              <a:rPr kumimoji="1" lang="ja-JP" altLang="en-US" smtClean="0"/>
              <a:t>2020/5/1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7094ED3-93F4-064E-BC6E-7632CE0338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1EAA053-8F06-E540-B3E5-D1E9CAE920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E6FED-AF57-1140-9F16-FE5E9289E6A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983360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F445264-D66A-6142-B2B1-1C8FA1FB0AB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0455346E-5483-9344-81D9-6F63CF9E585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11B50B2-31AB-7D4E-972B-D61D79617F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3F11D4-5BE0-7942-80BE-75A29E70E498}" type="datetimeFigureOut">
              <a:rPr kumimoji="1" lang="ja-JP" altLang="en-US" smtClean="0"/>
              <a:t>2020/5/1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4710144-F06B-AB48-8999-B60BA5451F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EBDFAC4-10DB-604F-BE9F-06059F8FBD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E6FED-AF57-1140-9F16-FE5E9289E6A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487887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A1529C8-7CF0-EB47-910B-7F0C7F5A1D1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352FAC2E-B963-B349-A6C4-6D2655653E7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424D9ABF-DBEA-F649-B926-EE9DBE7E18A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88BD91E8-289F-7946-812C-2BA2E97392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3F11D4-5BE0-7942-80BE-75A29E70E498}" type="datetimeFigureOut">
              <a:rPr kumimoji="1" lang="ja-JP" altLang="en-US" smtClean="0"/>
              <a:t>2020/5/1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A8FDCCB0-3C57-DE43-BF88-1A04D30558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37CE6E1F-EBF2-954B-A56C-69A2C4780F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E6FED-AF57-1140-9F16-FE5E9289E6A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275048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E2DC0B6-B494-CF4B-A4BD-9F351FC04D3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8BFC38E6-46BC-E746-945F-D108B93407B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9ECA2980-8C82-7E46-B12D-4BA9661A475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211513FB-9380-E14C-B31A-7ADEF89CC90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55F410DF-BC2B-9744-95BA-B26625C7977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DB5D5E2F-B40A-7D40-A9B4-80FA67E74F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3F11D4-5BE0-7942-80BE-75A29E70E498}" type="datetimeFigureOut">
              <a:rPr kumimoji="1" lang="ja-JP" altLang="en-US" smtClean="0"/>
              <a:t>2020/5/18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637B46F8-A949-3540-8D2C-80C81F4032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3E02884B-6341-B94F-A717-F9AC3FEE18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E6FED-AF57-1140-9F16-FE5E9289E6A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839875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A447EEA-76AD-4646-87D0-22A17AC768F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B1100BB8-BDBE-AA47-930A-F1A5ACCBD9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3F11D4-5BE0-7942-80BE-75A29E70E498}" type="datetimeFigureOut">
              <a:rPr kumimoji="1" lang="ja-JP" altLang="en-US" smtClean="0"/>
              <a:t>2020/5/18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87F25DCC-B089-7143-A788-798142506C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3EF41BF7-D2D8-BD44-996E-615604327E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E6FED-AF57-1140-9F16-FE5E9289E6A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248701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FC93D21B-87EE-4747-AF77-4EF771AE0D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3F11D4-5BE0-7942-80BE-75A29E70E498}" type="datetimeFigureOut">
              <a:rPr kumimoji="1" lang="ja-JP" altLang="en-US" smtClean="0"/>
              <a:t>2020/5/18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AC447478-A8CD-ED4A-A6C1-174AB45D11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5B09F7D3-A6C8-6A42-8A44-5DAA974912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E6FED-AF57-1140-9F16-FE5E9289E6A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316218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C4F4D22-A30C-784F-BBFC-C1DF5F05BF1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2F511668-AE5D-0E4E-ABE0-80B14B7302B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ABAF7327-F2B6-F044-9E59-29DFA0A2207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20AB17FB-467B-9243-BD08-D43E8DD9B8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3F11D4-5BE0-7942-80BE-75A29E70E498}" type="datetimeFigureOut">
              <a:rPr kumimoji="1" lang="ja-JP" altLang="en-US" smtClean="0"/>
              <a:t>2020/5/1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85DC0FFF-42ED-CB4D-B88D-2CF08C86CF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49492123-CE37-924A-A7AC-F3DB281CEB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E6FED-AF57-1140-9F16-FE5E9289E6A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080972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DC495C6-AA5E-8148-9E37-82EB7323438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5CA38AE9-1FFA-AF47-9F1F-722285E32F7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C681FBBE-A0AC-0C46-800F-9397E74F993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8489D7CF-6706-364C-BC21-70E83E2F90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3F11D4-5BE0-7942-80BE-75A29E70E498}" type="datetimeFigureOut">
              <a:rPr kumimoji="1" lang="ja-JP" altLang="en-US" smtClean="0"/>
              <a:t>2020/5/1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C07BF4AB-C91E-5143-99C2-4E8B7C84E4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FB9A1715-1766-1447-B6B7-B60EB4B9C5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E6FED-AF57-1140-9F16-FE5E9289E6A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937554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9B8C8C51-2C8E-1348-894A-B6936E09779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8C54AF04-4FEB-3E4A-8584-4882362F84E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C2052CB-D293-7B40-9665-86CC0601A95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B3F11D4-5BE0-7942-80BE-75A29E70E498}" type="datetimeFigureOut">
              <a:rPr kumimoji="1" lang="ja-JP" altLang="en-US" smtClean="0"/>
              <a:t>2020/5/1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A86C9FC-2CF2-CA4C-8C1D-BF2A8D6F4B8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81C7893-CDBE-8643-8934-408B9A84962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4E6FED-AF57-1140-9F16-FE5E9289E6A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709400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E14F6818-8D92-8B44-AD69-E40A95238966}"/>
              </a:ext>
            </a:extLst>
          </p:cNvPr>
          <p:cNvSpPr/>
          <p:nvPr/>
        </p:nvSpPr>
        <p:spPr>
          <a:xfrm>
            <a:off x="0" y="173017"/>
            <a:ext cx="12191999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600" dirty="0">
                <a:latin typeface="Helvetica" pitchFamily="2" charset="0"/>
              </a:rPr>
              <a:t>Supplementary </a:t>
            </a:r>
            <a:r>
              <a:rPr lang="en-US" altLang="ja-JP" sz="1600">
                <a:latin typeface="Helvetica" pitchFamily="2" charset="0"/>
              </a:rPr>
              <a:t>Figure 5.  </a:t>
            </a:r>
            <a:r>
              <a:rPr lang="ja-JP" altLang="en-US" sz="1600">
                <a:latin typeface="Helvetica" pitchFamily="2" charset="0"/>
              </a:rPr>
              <a:t>ROC curves of Tasks 1, 2, and 3 for classifying the ESSQ qualification status based on ALL score</a:t>
            </a:r>
            <a:r>
              <a:rPr lang="en-US" altLang="ja-JP" sz="1600" dirty="0">
                <a:latin typeface="Helvetica" pitchFamily="2" charset="0"/>
              </a:rPr>
              <a:t>s</a:t>
            </a:r>
            <a:endParaRPr lang="ja-JP" altLang="en-US" sz="1600">
              <a:latin typeface="Helvetica" pitchFamily="2" charset="0"/>
            </a:endParaRPr>
          </a:p>
        </p:txBody>
      </p:sp>
      <p:pic>
        <p:nvPicPr>
          <p:cNvPr id="6" name="図 5">
            <a:extLst>
              <a:ext uri="{FF2B5EF4-FFF2-40B4-BE49-F238E27FC236}">
                <a16:creationId xmlns:a16="http://schemas.microsoft.com/office/drawing/2014/main" id="{D51E9144-334C-7848-9C7B-E76F073AAEF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84267" y="782540"/>
            <a:ext cx="10423464" cy="5902443"/>
          </a:xfrm>
          <a:prstGeom prst="rect">
            <a:avLst/>
          </a:prstGeom>
        </p:spPr>
      </p:pic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54CE09C3-2C36-DB49-AABF-DA335A2AED5A}"/>
              </a:ext>
            </a:extLst>
          </p:cNvPr>
          <p:cNvSpPr txBox="1"/>
          <p:nvPr/>
        </p:nvSpPr>
        <p:spPr>
          <a:xfrm>
            <a:off x="8013586" y="1241118"/>
            <a:ext cx="2360583" cy="369332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b="1" dirty="0">
                <a:latin typeface="Helvetica" pitchFamily="2" charset="0"/>
              </a:rPr>
              <a:t>     Task 1                  </a:t>
            </a:r>
            <a:endParaRPr kumimoji="1" lang="ja-JP" altLang="en-US" b="1">
              <a:latin typeface="Helvetica" pitchFamily="2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3B5E288C-780F-F84F-9C79-788B3F388124}"/>
              </a:ext>
            </a:extLst>
          </p:cNvPr>
          <p:cNvSpPr txBox="1"/>
          <p:nvPr/>
        </p:nvSpPr>
        <p:spPr>
          <a:xfrm>
            <a:off x="8024582" y="1817722"/>
            <a:ext cx="2360583" cy="369332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b="1" dirty="0">
                <a:latin typeface="Helvetica" pitchFamily="2" charset="0"/>
              </a:rPr>
              <a:t>     Task 3                  </a:t>
            </a:r>
            <a:endParaRPr kumimoji="1" lang="ja-JP" altLang="en-US" b="1">
              <a:latin typeface="Helvetica" pitchFamily="2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67978670-C60A-1445-988F-04A2344D1DD1}"/>
              </a:ext>
            </a:extLst>
          </p:cNvPr>
          <p:cNvSpPr txBox="1"/>
          <p:nvPr/>
        </p:nvSpPr>
        <p:spPr>
          <a:xfrm>
            <a:off x="8005577" y="1534134"/>
            <a:ext cx="2360583" cy="369332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b="1" dirty="0">
                <a:latin typeface="Helvetica" pitchFamily="2" charset="0"/>
              </a:rPr>
              <a:t>     Task 2                  </a:t>
            </a:r>
            <a:endParaRPr kumimoji="1" lang="ja-JP" altLang="en-US" b="1">
              <a:latin typeface="Helvetica" pitchFamily="2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552432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8</TotalTime>
  <Words>33</Words>
  <Application>Microsoft Macintosh PowerPoint</Application>
  <PresentationFormat>ワイド画面</PresentationFormat>
  <Paragraphs>4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Helvetica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安部 崇重</dc:creator>
  <cp:lastModifiedBy>安部 崇重</cp:lastModifiedBy>
  <cp:revision>11</cp:revision>
  <dcterms:created xsi:type="dcterms:W3CDTF">2019-12-01T09:17:36Z</dcterms:created>
  <dcterms:modified xsi:type="dcterms:W3CDTF">2020-05-18T05:17:56Z</dcterms:modified>
</cp:coreProperties>
</file>